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68007" autoAdjust="0"/>
  </p:normalViewPr>
  <p:slideViewPr>
    <p:cSldViewPr snapToGrid="0">
      <p:cViewPr varScale="1">
        <p:scale>
          <a:sx n="70" d="100"/>
          <a:sy n="70" d="100"/>
        </p:scale>
        <p:origin x="2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llory Lee" userId="f985e002-1b8e-4c00-a3f0-6d28541faa96" providerId="ADAL" clId="{FACDB096-C5FB-43B9-ABF9-7184B91131AC}"/>
    <pc:docChg chg="modSld">
      <pc:chgData name="Mallory Lee" userId="f985e002-1b8e-4c00-a3f0-6d28541faa96" providerId="ADAL" clId="{FACDB096-C5FB-43B9-ABF9-7184B91131AC}" dt="2022-08-24T15:54:30.064" v="1" actId="20577"/>
      <pc:docMkLst>
        <pc:docMk/>
      </pc:docMkLst>
      <pc:sldChg chg="modSp mod">
        <pc:chgData name="Mallory Lee" userId="f985e002-1b8e-4c00-a3f0-6d28541faa96" providerId="ADAL" clId="{FACDB096-C5FB-43B9-ABF9-7184B91131AC}" dt="2022-08-24T15:54:30.064" v="1" actId="20577"/>
        <pc:sldMkLst>
          <pc:docMk/>
          <pc:sldMk cId="1516832301" sldId="267"/>
        </pc:sldMkLst>
        <pc:spChg chg="mod">
          <ac:chgData name="Mallory Lee" userId="f985e002-1b8e-4c00-a3f0-6d28541faa96" providerId="ADAL" clId="{FACDB096-C5FB-43B9-ABF9-7184B91131AC}" dt="2022-08-24T15:54:30.064" v="1" actId="20577"/>
          <ac:spMkLst>
            <pc:docMk/>
            <pc:sldMk cId="1516832301" sldId="267"/>
            <ac:spMk id="4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CD0FEB-B14F-4DA7-B268-0CE69CC15BEC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39E335-849B-451D-B2BD-8FA0BFB3EE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0047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Question Mark: “Image by </a:t>
            </a:r>
            <a:r>
              <a:rPr lang="en-US" dirty="0" err="1"/>
              <a:t>rawpixel</a:t>
            </a:r>
            <a:r>
              <a:rPr lang="en-US" dirty="0"/>
              <a:t>, retrieved from:  https://www.freepik.com/free-photo/hands-holding-question-mark-symbol_3476817.htm#query=Question%20mark&amp;position=21&amp;from_view=search on December 2, 2019. Image is in the public domain.” </a:t>
            </a:r>
          </a:p>
          <a:p>
            <a:r>
              <a:rPr lang="en-US" dirty="0"/>
              <a:t>Attribution copied link: &lt;a </a:t>
            </a:r>
            <a:r>
              <a:rPr lang="en-US" dirty="0" err="1"/>
              <a:t>href</a:t>
            </a:r>
            <a:r>
              <a:rPr lang="en-US" dirty="0"/>
              <a:t>="https://www.freepik.com/photos/question-mark-icon"&gt;Question mark icon photo created by rawpixel.com - www.freepik.com&lt;/a&gt; </a:t>
            </a:r>
          </a:p>
          <a:p>
            <a:endParaRPr lang="en-US" dirty="0"/>
          </a:p>
          <a:p>
            <a:r>
              <a:rPr lang="en-US" dirty="0"/>
              <a:t>Doctor Jacket: “Image by DarkoStojanovic-638422, retrieved from:  https://pixabay.com/photos/doctor-medical-medicine-health-563428/ on January 9, 2020. Image is in the public domain.”</a:t>
            </a:r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39E335-849B-451D-B2BD-8FA0BFB3EE6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2586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96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074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395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015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027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978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343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413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249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680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61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499D6-0D33-42B3-A7CB-472100BA2CE6}" type="datetimeFigureOut">
              <a:rPr lang="en-US" smtClean="0"/>
              <a:t>8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95289-A7E9-40D2-8CA4-129FA4771D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808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382715" y="-112839"/>
            <a:ext cx="920554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ew </a:t>
            </a:r>
            <a:r>
              <a:rPr kumimoji="0" lang="en-US" sz="3200" b="0" i="1" u="sng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novative</a:t>
            </a:r>
            <a:r>
              <a:rPr kumimoji="0" lang="en-US" sz="32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Faculty Development Program</a:t>
            </a:r>
            <a:endParaRPr kumimoji="0" lang="en-US" sz="3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Baskerville Old Face" panose="02020602080505020303" pitchFamily="18" charset="0"/>
              <a:ea typeface="+mn-ea"/>
              <a:cs typeface="+mn-cs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2619666" y="335779"/>
            <a:ext cx="980950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200" b="0" i="0" u="none" strike="noStrike" kern="1200" cap="none" spc="0" normalizeH="0" baseline="0" noProof="0" dirty="0">
                <a:ln>
                  <a:noFill/>
                </a:ln>
                <a:solidFill>
                  <a:srgbClr val="ED7D31">
                    <a:lumMod val="75000"/>
                  </a:srgbClr>
                </a:solidFill>
                <a:effectLst/>
                <a:uLnTx/>
                <a:uFillTx/>
                <a:latin typeface="Baskerville Old Face" panose="02020602080505020303" pitchFamily="18" charset="0"/>
                <a:ea typeface="+mn-ea"/>
                <a:cs typeface="+mn-cs"/>
              </a:rPr>
              <a:t>Tuesday’s</a:t>
            </a:r>
            <a:r>
              <a:rPr kumimoji="0" lang="en-US" sz="32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Baskerville Old Face" panose="02020602080505020303" pitchFamily="18" charset="0"/>
                <a:ea typeface="+mn-ea"/>
                <a:cs typeface="+mn-cs"/>
              </a:rPr>
              <a:t> Teaching </a:t>
            </a:r>
            <a:r>
              <a:rPr kumimoji="0" lang="en-US" sz="3200" b="0" i="0" u="none" strike="noStrike" kern="1200" cap="none" spc="0" normalizeH="0" baseline="0" noProof="0" dirty="0">
                <a:ln>
                  <a:noFill/>
                </a:ln>
                <a:solidFill>
                  <a:srgbClr val="ED7D31">
                    <a:lumMod val="75000"/>
                  </a:srgbClr>
                </a:solidFill>
                <a:effectLst/>
                <a:uLnTx/>
                <a:uFillTx/>
                <a:latin typeface="Baskerville Old Face" panose="02020602080505020303" pitchFamily="18" charset="0"/>
                <a:ea typeface="+mn-ea"/>
                <a:cs typeface="+mn-cs"/>
              </a:rPr>
              <a:t>Tips</a:t>
            </a:r>
            <a:r>
              <a:rPr kumimoji="0" lang="en-US" sz="2800" b="0" i="0" u="none" strike="noStrike" kern="1200" cap="none" spc="0" normalizeH="0" baseline="0" noProof="0" dirty="0">
                <a:ln>
                  <a:noFill/>
                </a:ln>
                <a:solidFill>
                  <a:srgbClr val="ED7D31">
                    <a:lumMod val="75000"/>
                  </a:srgbClr>
                </a:solidFill>
                <a:effectLst/>
                <a:uLnTx/>
                <a:uFillTx/>
                <a:latin typeface="Baskerville Old Face" panose="02020602080505020303" pitchFamily="18" charset="0"/>
                <a:ea typeface="+mn-ea"/>
                <a:cs typeface="+mn-cs"/>
              </a:rPr>
              <a:t>:       </a:t>
            </a:r>
            <a:r>
              <a:rPr kumimoji="0" lang="en-US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Baskerville Old Face" panose="02020602080505020303" pitchFamily="18" charset="0"/>
                <a:ea typeface="+mn-ea"/>
                <a:cs typeface="+mn-cs"/>
              </a:rPr>
              <a:t>Evaluation and Feedback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-16907" y="920746"/>
            <a:ext cx="6380351" cy="5755422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sng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Baskerville Old Face" panose="02020602080505020303" pitchFamily="18" charset="0"/>
                <a:ea typeface="+mn-ea"/>
                <a:cs typeface="+mn-cs"/>
              </a:rPr>
              <a:t>How Will it Work?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00" b="0" i="0" u="sng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Baskerville Old Face" panose="02020602080505020303" pitchFamily="18" charset="0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mpletely 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utomated 14-week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ncapsulated course via email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view a short online video regarding Evaluation and Feedback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600" b="0" i="0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Once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 week on Tuesday receive 1 email that provides an example of an effective feedback technique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ocus on </a:t>
            </a:r>
            <a:r>
              <a:rPr kumimoji="0" lang="en-US" sz="1600" b="1" i="0" u="sng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acticing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at skill for the next week along with your other feedback methods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t the end of the course, submit a short reflection from a prompt provided and a course evaluat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ttest to participating in 11/14 weeks. Receive a </a:t>
            </a:r>
            <a:r>
              <a:rPr kumimoji="0" lang="en-US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urse certificate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d </a:t>
            </a:r>
            <a:r>
              <a:rPr kumimoji="0" lang="en-US" sz="16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up to 7.25 CMEs</a:t>
            </a: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486501" y="732938"/>
            <a:ext cx="145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400" b="0" i="0" u="none" strike="noStrike" kern="1200" cap="none" spc="0" normalizeH="0" baseline="0" noProof="0" dirty="0">
                <a:ln>
                  <a:noFill/>
                </a:ln>
                <a:solidFill>
                  <a:srgbClr val="ED7D31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Dat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446227" y="1160707"/>
            <a:ext cx="5657632" cy="4339650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esented by: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ED7D31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lisa Zenni, M.D.              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ssociate Dean for Educational Affairs  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ofessor of Pediatric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00206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455582" y="4355899"/>
            <a:ext cx="5166948" cy="1015663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earning Objectives:</a:t>
            </a: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cognize the importance of providing effective feedback to trainees.</a:t>
            </a: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st examples of feedback strategies in the domains of language, structure, and culture.</a:t>
            </a: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rabicPeriod"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monstrate effective feedback strategies with trainees.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-16907" y="4463621"/>
            <a:ext cx="49217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sng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Baskerville Old Face" panose="02020602080505020303" pitchFamily="18" charset="0"/>
                <a:ea typeface="+mn-ea"/>
                <a:cs typeface="+mn-cs"/>
              </a:rPr>
              <a:t>Why Do This?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0" y="4863731"/>
            <a:ext cx="637279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ssists faculty in documenting faculty development</a:t>
            </a: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206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eets ACGME topic area of “as teachers”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457200" marR="0" lvl="0" indent="-4572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 emails utilize visuospatial cues and phonologic (auditory) processing to help encode into Long Term Memory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                            Questions? Email: XXXX</a:t>
            </a:r>
            <a:endParaRPr kumimoji="0" lang="en-US" sz="1200" b="0" i="0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446227" y="5697293"/>
            <a:ext cx="5657632" cy="923330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Contact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: For more information, contact </a:t>
            </a:r>
            <a:r>
              <a:rPr kumimoji="0" lang="en-US" sz="1000" b="0" i="0" u="sng" strike="noStrike" kern="1200" cap="none" spc="0" normalizeH="0" baseline="0" noProof="0" dirty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XXX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at XXX or </a:t>
            </a:r>
            <a:r>
              <a:rPr kumimoji="0" lang="en-US" sz="1000" b="0" i="0" u="sng" strike="noStrike" kern="1200" cap="none" spc="0" normalizeH="0" baseline="0" noProof="0" dirty="0">
                <a:ln>
                  <a:noFill/>
                </a:ln>
                <a:solidFill>
                  <a:srgbClr val="0000FF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XXXX 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at XXX in the XXX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Registration Required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: Click 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highlight>
                  <a:srgbClr val="FFFF00"/>
                </a:highlight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to register.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 Registration deadline is  XXX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000" b="1" i="1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000" b="1" i="1" u="sng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imes New Roman" panose="02020603050405020304" pitchFamily="18" charset="0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1" u="sng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+mn-cs"/>
              </a:rPr>
              <a:t>CME Language specific to your institution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4183C97-A67C-49F4-B2CC-6F6A9D7492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85487" y="2502101"/>
            <a:ext cx="4459065" cy="15475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683230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08</TotalTime>
  <Words>361</Words>
  <Application>Microsoft Office PowerPoint</Application>
  <PresentationFormat>Widescreen</PresentationFormat>
  <Paragraphs>6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Baskerville Old Face</vt:lpstr>
      <vt:lpstr>Calibri</vt:lpstr>
      <vt:lpstr>Calibri Light</vt:lpstr>
      <vt:lpstr>Times New Roman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lynych, Colleen</dc:creator>
  <cp:lastModifiedBy>Mallory Lee</cp:lastModifiedBy>
  <cp:revision>7</cp:revision>
  <dcterms:created xsi:type="dcterms:W3CDTF">2022-04-11T12:21:00Z</dcterms:created>
  <dcterms:modified xsi:type="dcterms:W3CDTF">2022-08-24T15:54:37Z</dcterms:modified>
</cp:coreProperties>
</file>